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373" y="-33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Mohamed\Desktop\Article%201%20Response%20Shift\syntaxe%20r\stat%20reponse%20reviewer's\resultats%20avec%20matching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hamed\Desktop\Article%201%20Response%20Shift\syntaxe%20r\stat%20reponse%20reviewer's\resultats%20avec%20matchin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Worsened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matching3!$B$3</c:f>
              <c:strCache>
                <c:ptCount val="1"/>
                <c:pt idx="0">
                  <c:v>PCS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3:$G$3</c:f>
              <c:numCache>
                <c:formatCode>General</c:formatCode>
                <c:ptCount val="5"/>
                <c:pt idx="0">
                  <c:v>49.571010000000001</c:v>
                </c:pt>
                <c:pt idx="1">
                  <c:v>35.652099999999997</c:v>
                </c:pt>
                <c:pt idx="2">
                  <c:v>30.591940000000001</c:v>
                </c:pt>
                <c:pt idx="3">
                  <c:v>38.863100000000003</c:v>
                </c:pt>
                <c:pt idx="4">
                  <c:v>70.22602000000000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matching3!$B$5</c:f>
              <c:strCache>
                <c:ptCount val="1"/>
                <c:pt idx="0">
                  <c:v>MCS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5:$G$5</c:f>
              <c:numCache>
                <c:formatCode>General</c:formatCode>
                <c:ptCount val="5"/>
                <c:pt idx="0">
                  <c:v>44.855440000000002</c:v>
                </c:pt>
                <c:pt idx="1">
                  <c:v>38.505119999999998</c:v>
                </c:pt>
                <c:pt idx="2">
                  <c:v>52.665590000000002</c:v>
                </c:pt>
                <c:pt idx="3">
                  <c:v>30.12677</c:v>
                </c:pt>
                <c:pt idx="4">
                  <c:v>35.72469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925248"/>
        <c:axId val="61926784"/>
      </c:lineChart>
      <c:catAx>
        <c:axId val="61925248"/>
        <c:scaling>
          <c:orientation val="minMax"/>
        </c:scaling>
        <c:delete val="0"/>
        <c:axPos val="b"/>
        <c:majorGridlines/>
        <c:majorTickMark val="out"/>
        <c:minorTickMark val="none"/>
        <c:tickLblPos val="nextTo"/>
        <c:crossAx val="61926784"/>
        <c:crosses val="autoZero"/>
        <c:auto val="1"/>
        <c:lblAlgn val="ctr"/>
        <c:lblOffset val="100"/>
        <c:noMultiLvlLbl val="0"/>
      </c:catAx>
      <c:valAx>
        <c:axId val="61926784"/>
        <c:scaling>
          <c:orientation val="minMax"/>
          <c:max val="100"/>
          <c:min val="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000" b="1" i="0" u="none" strike="noStrike" baseline="0">
                    <a:effectLst/>
                  </a:rPr>
                  <a:t>Variable importance score ( % IncMSE)</a:t>
                </a:r>
                <a:endParaRPr lang="fr-FR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619252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Not worsened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matching3!$J$3</c:f>
              <c:strCache>
                <c:ptCount val="1"/>
                <c:pt idx="0">
                  <c:v>PCS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K$3:$O$3</c:f>
              <c:numCache>
                <c:formatCode>General</c:formatCode>
                <c:ptCount val="5"/>
                <c:pt idx="0">
                  <c:v>61.844169999999998</c:v>
                </c:pt>
                <c:pt idx="1">
                  <c:v>33.909640000000003</c:v>
                </c:pt>
                <c:pt idx="2">
                  <c:v>36.104100000000003</c:v>
                </c:pt>
                <c:pt idx="3">
                  <c:v>60.007860000000001</c:v>
                </c:pt>
                <c:pt idx="4">
                  <c:v>62.16427000000000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matching3!$J$5</c:f>
              <c:strCache>
                <c:ptCount val="1"/>
                <c:pt idx="0">
                  <c:v>MCS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K$5:$O$5</c:f>
              <c:numCache>
                <c:formatCode>General</c:formatCode>
                <c:ptCount val="5"/>
                <c:pt idx="0">
                  <c:v>84.733810000000005</c:v>
                </c:pt>
                <c:pt idx="1">
                  <c:v>75.018789999999996</c:v>
                </c:pt>
                <c:pt idx="2">
                  <c:v>33.830919999999999</c:v>
                </c:pt>
                <c:pt idx="3">
                  <c:v>91.512839999999997</c:v>
                </c:pt>
                <c:pt idx="4">
                  <c:v>79.05580999999999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2227584"/>
        <c:axId val="62229120"/>
      </c:lineChart>
      <c:catAx>
        <c:axId val="62227584"/>
        <c:scaling>
          <c:orientation val="minMax"/>
        </c:scaling>
        <c:delete val="0"/>
        <c:axPos val="b"/>
        <c:majorGridlines/>
        <c:majorTickMark val="out"/>
        <c:minorTickMark val="none"/>
        <c:tickLblPos val="nextTo"/>
        <c:crossAx val="62229120"/>
        <c:crosses val="autoZero"/>
        <c:auto val="1"/>
        <c:lblAlgn val="ctr"/>
        <c:lblOffset val="100"/>
        <c:noMultiLvlLbl val="0"/>
      </c:catAx>
      <c:valAx>
        <c:axId val="6222912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6222758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6875</cdr:x>
      <cdr:y>0.07118</cdr:y>
    </cdr:from>
    <cdr:to>
      <cdr:x>0.26875</cdr:x>
      <cdr:y>0.40451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314325" y="195263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fr-FR" sz="1100"/>
        </a:p>
      </cdr:txBody>
    </cdr:sp>
  </cdr:relSizeAnchor>
  <cdr:relSizeAnchor xmlns:cdr="http://schemas.openxmlformats.org/drawingml/2006/chartDrawing">
    <cdr:from>
      <cdr:x>0.07153</cdr:x>
      <cdr:y>0.09743</cdr:y>
    </cdr:from>
    <cdr:to>
      <cdr:x>0.97778</cdr:x>
      <cdr:y>0.57943</cdr:y>
    </cdr:to>
    <cdr:sp macro="" textlink="">
      <cdr:nvSpPr>
        <cdr:cNvPr id="3" name="ZoneTexte 2"/>
        <cdr:cNvSpPr txBox="1"/>
      </cdr:nvSpPr>
      <cdr:spPr>
        <a:xfrm xmlns:a="http://schemas.openxmlformats.org/drawingml/2006/main">
          <a:off x="326865" y="300833"/>
          <a:ext cx="4141217" cy="14882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fr-FR" sz="1100" dirty="0"/>
            <a:t>             35%                 </a:t>
          </a:r>
          <a:r>
            <a:rPr lang="fr-FR" sz="1100" dirty="0" smtClean="0"/>
            <a:t>57</a:t>
          </a:r>
          <a:r>
            <a:rPr lang="fr-FR" sz="1100" dirty="0"/>
            <a:t>%</a:t>
          </a:r>
          <a:r>
            <a:rPr lang="fr-FR" sz="1100" baseline="0" dirty="0"/>
            <a:t>             </a:t>
          </a:r>
          <a:r>
            <a:rPr lang="fr-FR" sz="1100" baseline="0" dirty="0" smtClean="0"/>
            <a:t>68</a:t>
          </a:r>
          <a:r>
            <a:rPr lang="fr-FR" sz="1100" baseline="0" dirty="0"/>
            <a:t>%           </a:t>
          </a:r>
          <a:r>
            <a:rPr lang="fr-FR" sz="1100" baseline="0" dirty="0" smtClean="0"/>
            <a:t>74</a:t>
          </a:r>
          <a:r>
            <a:rPr lang="fr-FR" sz="1100" baseline="0" dirty="0"/>
            <a:t>%        </a:t>
          </a:r>
          <a:r>
            <a:rPr lang="fr-FR" sz="1100" baseline="0" dirty="0" smtClean="0"/>
            <a:t>     70</a:t>
          </a:r>
          <a:r>
            <a:rPr lang="fr-FR" sz="1100" baseline="0" dirty="0"/>
            <a:t>%     </a:t>
          </a:r>
          <a:endParaRPr lang="fr-FR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8662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9912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528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1137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9316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67279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0584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005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031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6532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182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9198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8232093"/>
              </p:ext>
            </p:extLst>
          </p:nvPr>
        </p:nvGraphicFramePr>
        <p:xfrm>
          <a:off x="-15786" y="1881187"/>
          <a:ext cx="4142262" cy="29803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2040384"/>
              </p:ext>
            </p:extLst>
          </p:nvPr>
        </p:nvGraphicFramePr>
        <p:xfrm>
          <a:off x="4071770" y="1881187"/>
          <a:ext cx="4892718" cy="29879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ZoneTexte 12"/>
          <p:cNvSpPr txBox="1"/>
          <p:nvPr/>
        </p:nvSpPr>
        <p:spPr>
          <a:xfrm>
            <a:off x="4499992" y="2188369"/>
            <a:ext cx="4857292" cy="1350167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100" dirty="0" smtClean="0"/>
              <a:t>45</a:t>
            </a:r>
            <a:r>
              <a:rPr lang="fr-FR" sz="1100" dirty="0"/>
              <a:t>%                 70%                 69%                    67%             </a:t>
            </a:r>
            <a:r>
              <a:rPr lang="fr-FR" sz="1100" dirty="0" smtClean="0"/>
              <a:t> </a:t>
            </a:r>
            <a:r>
              <a:rPr lang="fr-FR" sz="1100" dirty="0"/>
              <a:t>68%          % variance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8316416" y="4437112"/>
            <a:ext cx="4683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/>
              <a:t>Time</a:t>
            </a:r>
            <a:endParaRPr lang="fr-FR" sz="1100" dirty="0"/>
          </a:p>
        </p:txBody>
      </p:sp>
      <p:sp>
        <p:nvSpPr>
          <p:cNvPr id="11" name="ZoneTexte 10"/>
          <p:cNvSpPr txBox="1"/>
          <p:nvPr/>
        </p:nvSpPr>
        <p:spPr>
          <a:xfrm>
            <a:off x="3131840" y="5661925"/>
            <a:ext cx="1956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dditional </a:t>
            </a:r>
            <a:r>
              <a:rPr lang="en-US" dirty="0"/>
              <a:t>Figure </a:t>
            </a:r>
            <a:r>
              <a:rPr lang="en-US" dirty="0" smtClean="0"/>
              <a:t>1</a:t>
            </a:r>
            <a:endParaRPr lang="fr-FR" dirty="0"/>
          </a:p>
        </p:txBody>
      </p:sp>
      <p:sp>
        <p:nvSpPr>
          <p:cNvPr id="12" name="ZoneTexte 11"/>
          <p:cNvSpPr txBox="1"/>
          <p:nvPr/>
        </p:nvSpPr>
        <p:spPr>
          <a:xfrm>
            <a:off x="560782" y="5085184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13" name="ZoneTexte 12"/>
          <p:cNvSpPr txBox="1"/>
          <p:nvPr/>
        </p:nvSpPr>
        <p:spPr>
          <a:xfrm>
            <a:off x="4244374" y="5091675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41462418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39</Words>
  <Application>Microsoft Office PowerPoint</Application>
  <PresentationFormat>Affichage à l'écran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ohamed</dc:creator>
  <cp:lastModifiedBy>Karine B</cp:lastModifiedBy>
  <cp:revision>14</cp:revision>
  <dcterms:created xsi:type="dcterms:W3CDTF">2013-01-11T15:03:27Z</dcterms:created>
  <dcterms:modified xsi:type="dcterms:W3CDTF">2013-01-14T16:19:05Z</dcterms:modified>
</cp:coreProperties>
</file>